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4" r:id="rId2"/>
    <p:sldId id="263" r:id="rId3"/>
    <p:sldId id="261" r:id="rId4"/>
    <p:sldId id="262" r:id="rId5"/>
    <p:sldId id="265" r:id="rId6"/>
  </p:sldIdLst>
  <p:sldSz cx="12192000" cy="16256000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46" d="100"/>
          <a:sy n="46" d="100"/>
        </p:scale>
        <p:origin x="124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10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332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10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462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10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0914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10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1017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10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5178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10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5803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10/04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7089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10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23850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10/04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8874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10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9430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10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63178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9B6675-E010-4C41-BA87-77613E64EC47}" type="datetimeFigureOut">
              <a:rPr lang="en-GB" smtClean="0"/>
              <a:t>10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2836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0500" y="4242459"/>
            <a:ext cx="9945586" cy="6991598"/>
          </a:xfrm>
          <a:prstGeom prst="rect">
            <a:avLst/>
          </a:prstGeom>
          <a:noFill/>
        </p:spPr>
      </p:pic>
      <p:sp>
        <p:nvSpPr>
          <p:cNvPr id="5" name="Rectangle 4"/>
          <p:cNvSpPr/>
          <p:nvPr/>
        </p:nvSpPr>
        <p:spPr>
          <a:xfrm>
            <a:off x="1053935" y="1320908"/>
            <a:ext cx="1027215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number of SNPs identified from the wheat genomes based on Wheat IWGSC </a:t>
            </a:r>
            <a:r>
              <a:rPr lang="en-GB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fSeq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1.0</a:t>
            </a:r>
          </a:p>
        </p:txBody>
      </p:sp>
    </p:spTree>
    <p:extLst>
      <p:ext uri="{BB962C8B-B14F-4D97-AF65-F5344CB8AC3E}">
        <p14:creationId xmlns:p14="http://schemas.microsoft.com/office/powerpoint/2010/main" val="19006765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05888" y="169800"/>
            <a:ext cx="12011891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analysis of </a:t>
            </a:r>
            <a:r>
              <a:rPr lang="en-GB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ticum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es and subspecies based on A, B and D wheat genome. The ML tree was developed using the Jukes-Cantor model on concatenated SNPs. Numbers next to the branches are the ML bootstrap support values.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66" name="Picture 46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8749" y="1553637"/>
            <a:ext cx="9511394" cy="14158984"/>
          </a:xfrm>
          <a:prstGeom prst="rect">
            <a:avLst/>
          </a:prstGeom>
        </p:spPr>
      </p:pic>
      <p:sp>
        <p:nvSpPr>
          <p:cNvPr id="467" name="TextBox 466"/>
          <p:cNvSpPr txBox="1"/>
          <p:nvPr/>
        </p:nvSpPr>
        <p:spPr>
          <a:xfrm rot="16200000">
            <a:off x="2002641" y="911131"/>
            <a:ext cx="595099" cy="267326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sz="2667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me A</a:t>
            </a:r>
            <a:endParaRPr lang="en-GB" sz="2667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22719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9382" y="1327150"/>
            <a:ext cx="9848850" cy="136017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 rot="16200000">
            <a:off x="2002641" y="911131"/>
            <a:ext cx="595099" cy="267326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sz="2667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me B</a:t>
            </a:r>
            <a:endParaRPr lang="en-GB" sz="2667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46960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9122" y="595100"/>
            <a:ext cx="9718478" cy="1491649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 rot="16200000">
            <a:off x="2002641" y="911131"/>
            <a:ext cx="595099" cy="267326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sz="2667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me D</a:t>
            </a:r>
            <a:endParaRPr lang="en-GB" sz="2667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30100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>
            <a:grpSpLocks/>
          </p:cNvGrpSpPr>
          <p:nvPr/>
        </p:nvGrpSpPr>
        <p:grpSpPr>
          <a:xfrm>
            <a:off x="1436914" y="3494314"/>
            <a:ext cx="9829800" cy="9437915"/>
            <a:chOff x="0" y="0"/>
            <a:chExt cx="6912768" cy="5950999"/>
          </a:xfrm>
        </p:grpSpPr>
        <p:pic>
          <p:nvPicPr>
            <p:cNvPr id="5" name="Picture 4" descr="C:\Users\sebastin\Desktop\S2a.png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6912768" cy="234412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5" descr="C:\Users\sebastin\Desktop\S2b.pn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92088" y="2328198"/>
              <a:ext cx="5112568" cy="176105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6" descr="C:\Users\sebastin\Desktop\S2c.png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6024" y="4003868"/>
              <a:ext cx="6624737" cy="194713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8" name="Rectangle 7"/>
          <p:cNvSpPr/>
          <p:nvPr/>
        </p:nvSpPr>
        <p:spPr>
          <a:xfrm>
            <a:off x="859972" y="977857"/>
            <a:ext cx="1086394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incipal coordinate analysis (</a:t>
            </a:r>
            <a:r>
              <a:rPr lang="en-GB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oA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common and durum wheat, which classified </a:t>
            </a:r>
            <a:r>
              <a:rPr lang="en-GB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</a:t>
            </a:r>
            <a:r>
              <a:rPr lang="en-GB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rgidum</a:t>
            </a:r>
            <a:r>
              <a:rPr lang="en-GB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/ T. </a:t>
            </a:r>
            <a:r>
              <a:rPr lang="en-GB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estivum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cession at the species level based on 2,692 SNPs markers. Each node represents the individual cluster. </a:t>
            </a:r>
          </a:p>
        </p:txBody>
      </p:sp>
    </p:spTree>
    <p:extLst>
      <p:ext uri="{BB962C8B-B14F-4D97-AF65-F5344CB8AC3E}">
        <p14:creationId xmlns:p14="http://schemas.microsoft.com/office/powerpoint/2010/main" val="26029251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9</TotalTime>
  <Words>111</Words>
  <Application>Microsoft Office PowerPoint</Application>
  <PresentationFormat>Custom</PresentationFormat>
  <Paragraphs>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</dc:creator>
  <cp:lastModifiedBy>A</cp:lastModifiedBy>
  <cp:revision>32</cp:revision>
  <cp:lastPrinted>2020-03-27T00:33:21Z</cp:lastPrinted>
  <dcterms:created xsi:type="dcterms:W3CDTF">2020-03-17T08:41:47Z</dcterms:created>
  <dcterms:modified xsi:type="dcterms:W3CDTF">2020-04-10T06:17:17Z</dcterms:modified>
</cp:coreProperties>
</file>